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93" d="100"/>
          <a:sy n="93" d="100"/>
        </p:scale>
        <p:origin x="259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3070-C904-4AA2-8329-1102E4D22A80}" type="datetimeFigureOut">
              <a:rPr lang="en-AU" smtClean="0"/>
              <a:t>14/08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8B2A7-8EDE-431A-A51A-39565364AB1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273529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3070-C904-4AA2-8329-1102E4D22A80}" type="datetimeFigureOut">
              <a:rPr lang="en-AU" smtClean="0"/>
              <a:t>14/08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8B2A7-8EDE-431A-A51A-39565364AB1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3838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3070-C904-4AA2-8329-1102E4D22A80}" type="datetimeFigureOut">
              <a:rPr lang="en-AU" smtClean="0"/>
              <a:t>14/08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8B2A7-8EDE-431A-A51A-39565364AB1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23116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3070-C904-4AA2-8329-1102E4D22A80}" type="datetimeFigureOut">
              <a:rPr lang="en-AU" smtClean="0"/>
              <a:t>14/08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8B2A7-8EDE-431A-A51A-39565364AB1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26073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3070-C904-4AA2-8329-1102E4D22A80}" type="datetimeFigureOut">
              <a:rPr lang="en-AU" smtClean="0"/>
              <a:t>14/08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8B2A7-8EDE-431A-A51A-39565364AB1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67517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3070-C904-4AA2-8329-1102E4D22A80}" type="datetimeFigureOut">
              <a:rPr lang="en-AU" smtClean="0"/>
              <a:t>14/08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8B2A7-8EDE-431A-A51A-39565364AB1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765955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3070-C904-4AA2-8329-1102E4D22A80}" type="datetimeFigureOut">
              <a:rPr lang="en-AU" smtClean="0"/>
              <a:t>14/08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8B2A7-8EDE-431A-A51A-39565364AB1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867497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3070-C904-4AA2-8329-1102E4D22A80}" type="datetimeFigureOut">
              <a:rPr lang="en-AU" smtClean="0"/>
              <a:t>14/08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8B2A7-8EDE-431A-A51A-39565364AB1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89808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3070-C904-4AA2-8329-1102E4D22A80}" type="datetimeFigureOut">
              <a:rPr lang="en-AU" smtClean="0"/>
              <a:t>14/08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8B2A7-8EDE-431A-A51A-39565364AB1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55338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3070-C904-4AA2-8329-1102E4D22A80}" type="datetimeFigureOut">
              <a:rPr lang="en-AU" smtClean="0"/>
              <a:t>14/08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8B2A7-8EDE-431A-A51A-39565364AB1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21967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3070-C904-4AA2-8329-1102E4D22A80}" type="datetimeFigureOut">
              <a:rPr lang="en-AU" smtClean="0"/>
              <a:t>14/08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8B2A7-8EDE-431A-A51A-39565364AB1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88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933070-C904-4AA2-8329-1102E4D22A80}" type="datetimeFigureOut">
              <a:rPr lang="en-AU" smtClean="0"/>
              <a:t>14/08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68B2A7-8EDE-431A-A51A-39565364AB1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28885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288902" y="0"/>
            <a:ext cx="5873578" cy="1655762"/>
          </a:xfrm>
        </p:spPr>
        <p:txBody>
          <a:bodyPr>
            <a:normAutofit/>
          </a:bodyPr>
          <a:lstStyle/>
          <a:p>
            <a:r>
              <a:rPr lang="en-US" sz="1200" b="1" dirty="0"/>
              <a:t>Supplementary Figure 1. </a:t>
            </a:r>
            <a:r>
              <a:rPr lang="en-US" sz="1200" dirty="0"/>
              <a:t>Individual participant ankle angles in walking and running. Rotation about the ankle across all 3 planes for walking and running. Each participant is represented by one </a:t>
            </a:r>
            <a:r>
              <a:rPr lang="en-US" sz="1200" dirty="0" err="1" smtClean="0"/>
              <a:t>colour</a:t>
            </a:r>
            <a:r>
              <a:rPr lang="en-US" sz="1200" dirty="0"/>
              <a:t>. A solid line signifies the rotations produced by optical motion capture (OMC), whereas, a dashed line signifies rotations produced by biplanar videoradiography (BVR). </a:t>
            </a:r>
            <a:endParaRPr lang="en-AU" sz="1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361" y="0"/>
            <a:ext cx="567724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58164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4466968" cy="1325563"/>
          </a:xfrm>
        </p:spPr>
        <p:txBody>
          <a:bodyPr>
            <a:noAutofit/>
          </a:bodyPr>
          <a:lstStyle/>
          <a:p>
            <a:r>
              <a:rPr lang="en-US" sz="1200" b="1" dirty="0" smtClean="0"/>
              <a:t> Supplementary Figure 2. </a:t>
            </a:r>
            <a:r>
              <a:rPr lang="en-US" sz="1200" dirty="0" smtClean="0"/>
              <a:t>Individual participant medial longitudinal arch (MLA) angle across stance. Each participant is represented by one </a:t>
            </a:r>
            <a:r>
              <a:rPr lang="en-US" sz="1200" dirty="0" err="1" smtClean="0"/>
              <a:t>colour</a:t>
            </a:r>
            <a:r>
              <a:rPr lang="en-US" sz="1200" dirty="0" smtClean="0"/>
              <a:t>. A solid line signifies the MLA produced by optical motion capture (OMC), whereas, a dashed line signifies MLA produced by biplanar videoradiography (BVR).</a:t>
            </a:r>
            <a:r>
              <a:rPr lang="en-US" sz="1200" b="1" dirty="0" smtClean="0"/>
              <a:t> </a:t>
            </a:r>
            <a:r>
              <a:rPr lang="en-AU" sz="1200" dirty="0" smtClean="0"/>
              <a:t/>
            </a:r>
            <a:br>
              <a:rPr lang="en-AU" sz="1200" dirty="0" smtClean="0"/>
            </a:br>
            <a:endParaRPr lang="en-AU" sz="1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690688"/>
            <a:ext cx="4230624" cy="2194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73319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5817973" cy="1325563"/>
          </a:xfrm>
        </p:spPr>
        <p:txBody>
          <a:bodyPr>
            <a:normAutofit/>
          </a:bodyPr>
          <a:lstStyle/>
          <a:p>
            <a:r>
              <a:rPr lang="en-US" sz="1200" b="1" dirty="0" smtClean="0"/>
              <a:t>Supplementary Figure 3. </a:t>
            </a:r>
            <a:r>
              <a:rPr lang="en-US" sz="1200" dirty="0" smtClean="0"/>
              <a:t>Representation of the linear fit model (LFM) analysis for one participant comparing virtual and motion capture data for ankle angle across stance. The x-axis represents the virtual data where the y-axis represents the motion capture data. The grey dots represent the waveform data where the purple bar represents the result of the polynomial fit. </a:t>
            </a:r>
            <a:r>
              <a:rPr lang="en-AU" sz="1200" dirty="0" smtClean="0"/>
              <a:t/>
            </a:r>
            <a:br>
              <a:rPr lang="en-AU" sz="1200" dirty="0" smtClean="0"/>
            </a:br>
            <a:endParaRPr lang="en-AU" sz="1200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2456" y="1591834"/>
            <a:ext cx="2886456" cy="3617976"/>
          </a:xfrm>
        </p:spPr>
      </p:pic>
    </p:spTree>
    <p:extLst>
      <p:ext uri="{BB962C8B-B14F-4D97-AF65-F5344CB8AC3E}">
        <p14:creationId xmlns:p14="http://schemas.microsoft.com/office/powerpoint/2010/main" val="30024879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4277497" cy="1325563"/>
          </a:xfrm>
        </p:spPr>
        <p:txBody>
          <a:bodyPr>
            <a:noAutofit/>
          </a:bodyPr>
          <a:lstStyle/>
          <a:p>
            <a:r>
              <a:rPr lang="en-US" sz="1100" b="1" dirty="0" smtClean="0"/>
              <a:t>Supplementary Figure 4. </a:t>
            </a:r>
            <a:r>
              <a:rPr lang="en-US" sz="1100" dirty="0" smtClean="0"/>
              <a:t>Representation of the linear fit model (LFM) analysis for one participant comparing virtual and motion capture data for the medial longitudinal arch (MLA) angle. The x-axis represents the virtual data where the y-axis represents the motion capture data. The grey dots represent the waveform data where the purple bar represents the result of the polynomial fit.</a:t>
            </a:r>
            <a:r>
              <a:rPr lang="en-AU" sz="1100" dirty="0" smtClean="0"/>
              <a:t/>
            </a:r>
            <a:br>
              <a:rPr lang="en-AU" sz="1100" dirty="0" smtClean="0"/>
            </a:br>
            <a:endParaRPr lang="en-AU" sz="1100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634" y="1623689"/>
            <a:ext cx="2871216" cy="1377696"/>
          </a:xfrm>
        </p:spPr>
      </p:pic>
    </p:spTree>
    <p:extLst>
      <p:ext uri="{BB962C8B-B14F-4D97-AF65-F5344CB8AC3E}">
        <p14:creationId xmlns:p14="http://schemas.microsoft.com/office/powerpoint/2010/main" val="8844025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7</TotalTime>
  <Words>245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 Supplementary Figure 2. Individual participant medial longitudinal arch (MLA) angle across stance. Each participant is represented by one colour. A solid line signifies the MLA produced by optical motion capture (OMC), whereas, a dashed line signifies MLA produced by biplanar videoradiography (BVR).  </vt:lpstr>
      <vt:lpstr>Supplementary Figure 3. Representation of the linear fit model (LFM) analysis for one participant comparing virtual and motion capture data for ankle angle across stance. The x-axis represents the virtual data where the y-axis represents the motion capture data. The grey dots represent the waveform data where the purple bar represents the result of the polynomial fit.  </vt:lpstr>
      <vt:lpstr>Supplementary Figure 4. Representation of the linear fit model (LFM) analysis for one participant comparing virtual and motion capture data for the medial longitudinal arch (MLA) angle. The x-axis represents the virtual data where the y-axis represents the motion capture data. The grey dots represent the waveform data where the purple bar represents the result of the polynomial fit. </vt:lpstr>
    </vt:vector>
  </TitlesOfParts>
  <Company>The University of Queens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Kessler</dc:creator>
  <cp:lastModifiedBy>Sarah Kessler</cp:lastModifiedBy>
  <cp:revision>4</cp:revision>
  <dcterms:created xsi:type="dcterms:W3CDTF">2019-05-22T07:46:51Z</dcterms:created>
  <dcterms:modified xsi:type="dcterms:W3CDTF">2019-08-14T03:08:09Z</dcterms:modified>
</cp:coreProperties>
</file>